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35"/>
  </p:normalViewPr>
  <p:slideViewPr>
    <p:cSldViewPr snapToGrid="0" snapToObjects="1">
      <p:cViewPr varScale="1">
        <p:scale>
          <a:sx n="111" d="100"/>
          <a:sy n="111" d="100"/>
        </p:scale>
        <p:origin x="63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1FE675-805A-A242-A178-49913B8E87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2284033-4655-3146-815D-A77E41BEC2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35DBE4-B2A8-934B-986D-039CF4F15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4F339-F248-CE45-A752-CE7BDB45313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7B1424-4093-E549-A4D0-5FE95BB688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078D84-50EF-7A46-82C1-9981053BB2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807BA-5FDD-7146-8EC4-1FAB7F33CFD7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395240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DF541-BF11-3C45-827F-53106CACD8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363F26-CF0F-324A-AC41-F3A97596BE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3BC17A-F6AD-9346-8B81-3F3E19527B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4F339-F248-CE45-A752-CE7BDB45313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44B7BF-4379-0346-B48C-7E7155AA5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B133EF-62B9-D84D-97E8-950587114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807BA-5FDD-7146-8EC4-1FAB7F33CFD7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17918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E0B481-D830-E14A-8252-351BC0F222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58AC3F3-9192-DA43-87EF-9FF932BBB5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9BE7EE-569B-B442-A072-A41DB3745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4F339-F248-CE45-A752-CE7BDB45313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FE2369-ABA6-4649-8D1D-A38521A96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B6B435-AB35-124F-A1BE-5DBE5C12B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807BA-5FDD-7146-8EC4-1FAB7F33CFD7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887677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608ED3-7A23-204F-8918-75C195CBFD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9E112B-C186-0547-A501-4A4DF21BFB4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32713E-7233-C449-9C9D-271C4FB27C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4F339-F248-CE45-A752-CE7BDB45313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238656-BE0A-9343-AA42-DA2180859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2A58B8-B78E-8246-9A57-6B0A4EE2C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807BA-5FDD-7146-8EC4-1FAB7F33CFD7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009559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747FAD-8E92-1D4E-B694-20813BA261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D6FD6F-169F-8D47-BB69-6426CF2371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3567C6-4BEB-BA4D-ACD8-61D0B3D1F0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4F339-F248-CE45-A752-CE7BDB45313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E8F3C5-0AFE-C848-AA4D-A1E87DD53A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67F576-74BE-2B47-99BB-2D4CF172C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807BA-5FDD-7146-8EC4-1FAB7F33CFD7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4208689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630189-92E0-9642-9BF5-3D6A32519F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A8FB87-36F6-2D47-B46B-93BED8396A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7636F2-3BAB-B343-BB61-7A57751872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3BDDE7-B5BF-3D4E-9BBF-6C6808C01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4F339-F248-CE45-A752-CE7BDB45313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CA9742-E2F4-454A-890B-C868B72675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D0139E-FC4F-A146-88C8-039B2190B7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807BA-5FDD-7146-8EC4-1FAB7F33CFD7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444550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A16464-8CBD-7E49-85E9-56820D6395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DE7AAC-A6A8-EA4C-94E5-CFC304B7A0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355C13-20C8-9942-93BD-B5359DCEDE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72F933-8597-D84A-A1E8-1C80F550D9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BCBC29-4840-D645-A662-DBB03AB947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E6D822-5F57-4549-9E68-3EA2973F37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4F339-F248-CE45-A752-CE7BDB45313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17A0470-90B9-5B4B-80FE-6455F8B6B2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D38E98E-E1DC-5E4F-B760-DBBD2DFC6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807BA-5FDD-7146-8EC4-1FAB7F33CFD7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349902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E061CA-6946-C348-8D92-248471FD5B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11A3E9E-622F-E34F-9281-3ECF3B718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4F339-F248-CE45-A752-CE7BDB45313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0A19AF9-8F08-314C-9AA5-9FB3D43AD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B89220E-7EF0-B54A-BE61-FBEC6FAF4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807BA-5FDD-7146-8EC4-1FAB7F33CFD7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049066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22A257B-DDD6-B54D-9F49-6A7B67378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4F339-F248-CE45-A752-CE7BDB45313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069DCCB-C0CD-A341-9AF9-5D00E5A0D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A969E9-A77F-4A46-8644-3961214F6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807BA-5FDD-7146-8EC4-1FAB7F33CFD7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004898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C33844-9B43-084C-9CA9-92F4AAA26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97ADA7-B2D9-4E4A-A925-BDA2864BF6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F193D6-A1E6-C844-B423-888D0A1B8C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057436-8EBB-EE45-9178-7A4BBDC3EC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4F339-F248-CE45-A752-CE7BDB45313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AA4D43-9394-A54E-B34A-2A40511D3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300CB7-883F-6445-9133-C45AD06B9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807BA-5FDD-7146-8EC4-1FAB7F33CFD7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5312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2D1393-41A1-AA4D-A050-4DC341755C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20FB3B-AFFC-9F4C-A6E1-3715F899AE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E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7B4B52-6E92-4740-A710-8B927219D6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C116D2-F5A7-E842-A59A-EF0C2421BF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4F339-F248-CE45-A752-CE7BDB45313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FC834F-7A8C-5E49-887E-21C47A91FE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4F7230-11ED-1F4F-AA38-D99B28E8D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807BA-5FDD-7146-8EC4-1FAB7F33CFD7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8643611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E6329AD-41DD-D148-9A32-D7F1DEF392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8CC526-11C8-A14B-86E1-7CA72625B9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C51BDA-7629-7F42-ABAF-5254896AA7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B4F339-F248-CE45-A752-CE7BDB45313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58705F-D64E-2540-9F55-8789E5C66D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13D643-2EA5-9F40-8205-EB23EE373E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D807BA-5FDD-7146-8EC4-1FAB7F33CFD7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566068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96F0DCE-0E8A-9F42-8EBB-7BD102AFD2C1}"/>
              </a:ext>
            </a:extLst>
          </p:cNvPr>
          <p:cNvGrpSpPr/>
          <p:nvPr/>
        </p:nvGrpSpPr>
        <p:grpSpPr>
          <a:xfrm>
            <a:off x="2646680" y="1562735"/>
            <a:ext cx="5891530" cy="4483247"/>
            <a:chOff x="703580" y="1605597"/>
            <a:chExt cx="5891530" cy="4483247"/>
          </a:xfrm>
        </p:grpSpPr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DA802751-3934-E94C-AF13-479C4F262F20}"/>
                </a:ext>
              </a:extLst>
            </p:cNvPr>
            <p:cNvCxnSpPr/>
            <p:nvPr/>
          </p:nvCxnSpPr>
          <p:spPr>
            <a:xfrm>
              <a:off x="1502979" y="5707117"/>
              <a:ext cx="193390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6E853830-7B65-1241-BF57-8A04480A5C0C}"/>
                </a:ext>
              </a:extLst>
            </p:cNvPr>
            <p:cNvCxnSpPr/>
            <p:nvPr/>
          </p:nvCxnSpPr>
          <p:spPr>
            <a:xfrm>
              <a:off x="4162097" y="5707117"/>
              <a:ext cx="193390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A2214913-13B6-3641-9C8B-3FF0348A15F6}"/>
                </a:ext>
              </a:extLst>
            </p:cNvPr>
            <p:cNvSpPr/>
            <p:nvPr/>
          </p:nvSpPr>
          <p:spPr>
            <a:xfrm>
              <a:off x="1915104" y="5707117"/>
              <a:ext cx="98334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ES" dirty="0"/>
                <a:t>Deletion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354B824F-550F-D945-8427-11E993D1B448}"/>
                </a:ext>
              </a:extLst>
            </p:cNvPr>
            <p:cNvSpPr/>
            <p:nvPr/>
          </p:nvSpPr>
          <p:spPr>
            <a:xfrm>
              <a:off x="4493399" y="5719512"/>
              <a:ext cx="128631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ES" dirty="0"/>
                <a:t>No deletion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83A13E93-2B79-0045-B64F-C898D497AF1B}"/>
                </a:ext>
              </a:extLst>
            </p:cNvPr>
            <p:cNvGrpSpPr/>
            <p:nvPr/>
          </p:nvGrpSpPr>
          <p:grpSpPr>
            <a:xfrm>
              <a:off x="703580" y="1605597"/>
              <a:ext cx="5891530" cy="3838364"/>
              <a:chOff x="703580" y="1605597"/>
              <a:chExt cx="5891530" cy="3838364"/>
            </a:xfrm>
          </p:grpSpPr>
          <p:pic>
            <p:nvPicPr>
              <p:cNvPr id="14" name="Graphic 13">
                <a:extLst>
                  <a:ext uri="{FF2B5EF4-FFF2-40B4-BE49-F238E27FC236}">
                    <a16:creationId xmlns:a16="http://schemas.microsoft.com/office/drawing/2014/main" id="{C4543290-A62D-B643-B17F-E33E7E7CAA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tretch>
                <a:fillRect/>
              </a:stretch>
            </p:blipFill>
            <p:spPr>
              <a:xfrm>
                <a:off x="703580" y="1605597"/>
                <a:ext cx="5891530" cy="3827463"/>
              </a:xfrm>
              <a:prstGeom prst="rect">
                <a:avLst/>
              </a:prstGeom>
            </p:spPr>
          </p:pic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61C1D639-D152-5242-95AA-A5B6B23DE8EF}"/>
                  </a:ext>
                </a:extLst>
              </p:cNvPr>
              <p:cNvSpPr/>
              <p:nvPr/>
            </p:nvSpPr>
            <p:spPr>
              <a:xfrm>
                <a:off x="1205690" y="5213522"/>
                <a:ext cx="4887310" cy="23043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ES" dirty="0"/>
              </a:p>
            </p:txBody>
          </p:sp>
        </p:grp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FF7C8D16-0957-7844-BF9A-DF58C3715E40}"/>
                </a:ext>
              </a:extLst>
            </p:cNvPr>
            <p:cNvSpPr/>
            <p:nvPr/>
          </p:nvSpPr>
          <p:spPr>
            <a:xfrm>
              <a:off x="2900513" y="5259996"/>
              <a:ext cx="55976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ES" sz="1400" dirty="0"/>
                <a:t>MITE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8E0F4476-57B3-9847-A1C7-B4B3EC0671EB}"/>
                </a:ext>
              </a:extLst>
            </p:cNvPr>
            <p:cNvSpPr/>
            <p:nvPr/>
          </p:nvSpPr>
          <p:spPr>
            <a:xfrm>
              <a:off x="1477142" y="5257179"/>
              <a:ext cx="83388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ES" sz="1400" dirty="0"/>
                <a:t>NO MITE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F2C45EA3-267E-7B4A-9B94-CE76DFC461A4}"/>
                </a:ext>
              </a:extLst>
            </p:cNvPr>
            <p:cNvSpPr/>
            <p:nvPr/>
          </p:nvSpPr>
          <p:spPr>
            <a:xfrm>
              <a:off x="4236914" y="5268391"/>
              <a:ext cx="55976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ES" sz="1400" dirty="0"/>
                <a:t>MITE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F380968A-043D-7E4F-A8C4-91D4C2EFD367}"/>
                </a:ext>
              </a:extLst>
            </p:cNvPr>
            <p:cNvSpPr/>
            <p:nvPr/>
          </p:nvSpPr>
          <p:spPr>
            <a:xfrm>
              <a:off x="5386171" y="5259997"/>
              <a:ext cx="83388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ES" sz="1400" dirty="0"/>
                <a:t>NO MITE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67FF0381-64AB-504F-A84F-36051C8AB509}"/>
              </a:ext>
            </a:extLst>
          </p:cNvPr>
          <p:cNvSpPr txBox="1"/>
          <p:nvPr/>
        </p:nvSpPr>
        <p:spPr>
          <a:xfrm>
            <a:off x="556445" y="461661"/>
            <a:ext cx="913410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dirty="0"/>
              <a:t>Figure S7</a:t>
            </a:r>
            <a:r>
              <a:rPr lang="en-ES" dirty="0"/>
              <a:t>.  Grain width of varieties carrying </a:t>
            </a:r>
            <a:r>
              <a:rPr lang="en-US" dirty="0"/>
              <a:t>MITE-1</a:t>
            </a:r>
            <a:r>
              <a:rPr lang="en-ES" dirty="0">
                <a:effectLst/>
              </a:rPr>
              <a:t> insertion (</a:t>
            </a:r>
            <a:r>
              <a:rPr lang="en-US" dirty="0"/>
              <a:t>chr05:5364000-5365000</a:t>
            </a:r>
            <a:r>
              <a:rPr lang="en-ES" dirty="0">
                <a:effectLst/>
              </a:rPr>
              <a:t>) and the </a:t>
            </a:r>
          </a:p>
          <a:p>
            <a:r>
              <a:rPr lang="en-US" dirty="0"/>
              <a:t>deletion located 4,500 bp upstream the GSE5 gene</a:t>
            </a:r>
            <a:r>
              <a:rPr lang="en-ES" dirty="0">
                <a:effectLst/>
              </a:rPr>
              <a:t> described in </a:t>
            </a:r>
            <a:r>
              <a:rPr lang="en-US" dirty="0"/>
              <a:t>(Duan et al. 2017)</a:t>
            </a:r>
            <a:r>
              <a:rPr lang="en-ES" dirty="0">
                <a:effectLst/>
              </a:rPr>
              <a:t> .</a:t>
            </a:r>
            <a:endParaRPr lang="en-ES" dirty="0"/>
          </a:p>
        </p:txBody>
      </p:sp>
    </p:spTree>
    <p:extLst>
      <p:ext uri="{BB962C8B-B14F-4D97-AF65-F5344CB8AC3E}">
        <p14:creationId xmlns:p14="http://schemas.microsoft.com/office/powerpoint/2010/main" val="18817545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2</Words>
  <Application>Microsoft Macintosh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úl Castanera Andrés</dc:creator>
  <cp:lastModifiedBy>Raúl Castanera Andrés</cp:lastModifiedBy>
  <cp:revision>3</cp:revision>
  <dcterms:created xsi:type="dcterms:W3CDTF">2020-09-18T15:28:23Z</dcterms:created>
  <dcterms:modified xsi:type="dcterms:W3CDTF">2020-11-05T18:27:22Z</dcterms:modified>
</cp:coreProperties>
</file>